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oshida Shun" initials="YS" lastIdx="1" clrIdx="0">
    <p:extLst>
      <p:ext uri="{19B8F6BF-5375-455C-9EA6-DF929625EA0E}">
        <p15:presenceInfo xmlns:p15="http://schemas.microsoft.com/office/powerpoint/2012/main" userId="5de8db52ba4204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AF0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36" autoAdjust="0"/>
  </p:normalViewPr>
  <p:slideViewPr>
    <p:cSldViewPr snapToGrid="0">
      <p:cViewPr varScale="1">
        <p:scale>
          <a:sx n="79" d="100"/>
          <a:sy n="79" d="100"/>
        </p:scale>
        <p:origin x="30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6" d="100"/>
          <a:sy n="86" d="100"/>
        </p:scale>
        <p:origin x="3012" y="9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35CE6845-FC8A-5589-E550-CB0ABA511E7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769CA06-3ADF-D98A-3122-5ABDA7E4E01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71FF2-397B-4D7D-A8BA-55EC4F95E2F1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F1B76AC-7176-EC01-A24C-015C1CCD1A7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94C71A0-5AD2-30A0-0CFD-5FB86ADBAC8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5E11CA-A89F-4C9B-A308-319D2F0EA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123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454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065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45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076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1813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640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6465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5108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385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460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302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F2CEE-E263-44A6-83D7-9E3F5BB1B273}" type="datetimeFigureOut">
              <a:rPr kumimoji="1" lang="ja-JP" altLang="en-US" smtClean="0"/>
              <a:t>2023/1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88815-AD9F-4DAA-AF16-241AADA895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7660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tif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F37DD34E-2380-95C5-D491-D1A751966F54}"/>
              </a:ext>
            </a:extLst>
          </p:cNvPr>
          <p:cNvGrpSpPr/>
          <p:nvPr/>
        </p:nvGrpSpPr>
        <p:grpSpPr>
          <a:xfrm>
            <a:off x="4168913" y="3038225"/>
            <a:ext cx="1080000" cy="1080000"/>
            <a:chOff x="-1797039" y="3946653"/>
            <a:chExt cx="4315968" cy="4315968"/>
          </a:xfrm>
        </p:grpSpPr>
        <p:pic>
          <p:nvPicPr>
            <p:cNvPr id="152" name="図 151">
              <a:extLst>
                <a:ext uri="{FF2B5EF4-FFF2-40B4-BE49-F238E27FC236}">
                  <a16:creationId xmlns:a16="http://schemas.microsoft.com/office/drawing/2014/main" id="{65422BD8-097F-EAB9-80C7-1A59CA42A6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1797039" y="3946653"/>
              <a:ext cx="4315968" cy="4315968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54" name="正方形/長方形 153">
              <a:extLst>
                <a:ext uri="{FF2B5EF4-FFF2-40B4-BE49-F238E27FC236}">
                  <a16:creationId xmlns:a16="http://schemas.microsoft.com/office/drawing/2014/main" id="{B1FE73B5-9426-ABFC-A677-8B07334A2F1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-1031342" y="6291843"/>
              <a:ext cx="1080000" cy="108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3" name="グループ化 162">
            <a:extLst>
              <a:ext uri="{FF2B5EF4-FFF2-40B4-BE49-F238E27FC236}">
                <a16:creationId xmlns:a16="http://schemas.microsoft.com/office/drawing/2014/main" id="{E0AA4156-2450-DFC3-A623-EAA10EFBB92C}"/>
              </a:ext>
            </a:extLst>
          </p:cNvPr>
          <p:cNvGrpSpPr/>
          <p:nvPr/>
        </p:nvGrpSpPr>
        <p:grpSpPr>
          <a:xfrm>
            <a:off x="771699" y="3038225"/>
            <a:ext cx="1080000" cy="1080000"/>
            <a:chOff x="1153492" y="7253937"/>
            <a:chExt cx="1080000" cy="1080000"/>
          </a:xfrm>
        </p:grpSpPr>
        <p:grpSp>
          <p:nvGrpSpPr>
            <p:cNvPr id="159" name="グループ化 158">
              <a:extLst>
                <a:ext uri="{FF2B5EF4-FFF2-40B4-BE49-F238E27FC236}">
                  <a16:creationId xmlns:a16="http://schemas.microsoft.com/office/drawing/2014/main" id="{6CE6C1A7-7B96-C63E-E612-3929C6F45BB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53492" y="7253937"/>
              <a:ext cx="1080000" cy="1080000"/>
              <a:chOff x="-1792496" y="3933616"/>
              <a:chExt cx="4315968" cy="4315968"/>
            </a:xfrm>
          </p:grpSpPr>
          <p:pic>
            <p:nvPicPr>
              <p:cNvPr id="151" name="図 150">
                <a:extLst>
                  <a:ext uri="{FF2B5EF4-FFF2-40B4-BE49-F238E27FC236}">
                    <a16:creationId xmlns:a16="http://schemas.microsoft.com/office/drawing/2014/main" id="{0886C7BE-2D43-22D9-CD14-A794A5C905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1792496" y="3933616"/>
                <a:ext cx="4315968" cy="4315968"/>
              </a:xfrm>
              <a:prstGeom prst="rect">
                <a:avLst/>
              </a:prstGeom>
              <a:ln w="12700">
                <a:solidFill>
                  <a:schemeClr val="bg1"/>
                </a:solidFill>
              </a:ln>
            </p:spPr>
          </p:pic>
          <p:sp>
            <p:nvSpPr>
              <p:cNvPr id="155" name="正方形/長方形 154">
                <a:extLst>
                  <a:ext uri="{FF2B5EF4-FFF2-40B4-BE49-F238E27FC236}">
                    <a16:creationId xmlns:a16="http://schemas.microsoft.com/office/drawing/2014/main" id="{06E4F165-0E78-9AF8-CC01-19B79EE724E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-1031342" y="6298362"/>
                <a:ext cx="1080000" cy="1080000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>
                  <a:ln>
                    <a:solidFill>
                      <a:schemeClr val="bg1">
                        <a:lumMod val="95000"/>
                      </a:schemeClr>
                    </a:solidFill>
                  </a:ln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フリーフォーム: 図形 161">
              <a:extLst>
                <a:ext uri="{FF2B5EF4-FFF2-40B4-BE49-F238E27FC236}">
                  <a16:creationId xmlns:a16="http://schemas.microsoft.com/office/drawing/2014/main" id="{E698F8D3-3EDF-ACF7-644C-900586C67CD8}"/>
                </a:ext>
              </a:extLst>
            </p:cNvPr>
            <p:cNvSpPr/>
            <p:nvPr/>
          </p:nvSpPr>
          <p:spPr>
            <a:xfrm>
              <a:off x="1176156" y="7317406"/>
              <a:ext cx="1044468" cy="989462"/>
            </a:xfrm>
            <a:custGeom>
              <a:avLst/>
              <a:gdLst>
                <a:gd name="connsiteX0" fmla="*/ 890516 w 1044468"/>
                <a:gd name="connsiteY0" fmla="*/ 829101 h 989462"/>
                <a:gd name="connsiteX1" fmla="*/ 873457 w 1044468"/>
                <a:gd name="connsiteY1" fmla="*/ 825689 h 989462"/>
                <a:gd name="connsiteX2" fmla="*/ 829101 w 1044468"/>
                <a:gd name="connsiteY2" fmla="*/ 829101 h 989462"/>
                <a:gd name="connsiteX3" fmla="*/ 818866 w 1044468"/>
                <a:gd name="connsiteY3" fmla="*/ 835925 h 989462"/>
                <a:gd name="connsiteX4" fmla="*/ 801806 w 1044468"/>
                <a:gd name="connsiteY4" fmla="*/ 856397 h 989462"/>
                <a:gd name="connsiteX5" fmla="*/ 788158 w 1044468"/>
                <a:gd name="connsiteY5" fmla="*/ 873456 h 989462"/>
                <a:gd name="connsiteX6" fmla="*/ 781334 w 1044468"/>
                <a:gd name="connsiteY6" fmla="*/ 890516 h 989462"/>
                <a:gd name="connsiteX7" fmla="*/ 774510 w 1044468"/>
                <a:gd name="connsiteY7" fmla="*/ 965579 h 989462"/>
                <a:gd name="connsiteX8" fmla="*/ 743803 w 1044468"/>
                <a:gd name="connsiteY8" fmla="*/ 958755 h 989462"/>
                <a:gd name="connsiteX9" fmla="*/ 726743 w 1044468"/>
                <a:gd name="connsiteY9" fmla="*/ 948519 h 989462"/>
                <a:gd name="connsiteX10" fmla="*/ 685800 w 1044468"/>
                <a:gd name="connsiteY10" fmla="*/ 938283 h 989462"/>
                <a:gd name="connsiteX11" fmla="*/ 658504 w 1044468"/>
                <a:gd name="connsiteY11" fmla="*/ 941695 h 989462"/>
                <a:gd name="connsiteX12" fmla="*/ 644857 w 1044468"/>
                <a:gd name="connsiteY12" fmla="*/ 945107 h 989462"/>
                <a:gd name="connsiteX13" fmla="*/ 607325 w 1044468"/>
                <a:gd name="connsiteY13" fmla="*/ 968991 h 989462"/>
                <a:gd name="connsiteX14" fmla="*/ 593677 w 1044468"/>
                <a:gd name="connsiteY14" fmla="*/ 972403 h 989462"/>
                <a:gd name="connsiteX15" fmla="*/ 566382 w 1044468"/>
                <a:gd name="connsiteY15" fmla="*/ 968991 h 989462"/>
                <a:gd name="connsiteX16" fmla="*/ 542498 w 1044468"/>
                <a:gd name="connsiteY16" fmla="*/ 962167 h 989462"/>
                <a:gd name="connsiteX17" fmla="*/ 511791 w 1044468"/>
                <a:gd name="connsiteY17" fmla="*/ 968991 h 989462"/>
                <a:gd name="connsiteX18" fmla="*/ 467436 w 1044468"/>
                <a:gd name="connsiteY18" fmla="*/ 986050 h 989462"/>
                <a:gd name="connsiteX19" fmla="*/ 443552 w 1044468"/>
                <a:gd name="connsiteY19" fmla="*/ 989462 h 989462"/>
                <a:gd name="connsiteX20" fmla="*/ 375313 w 1044468"/>
                <a:gd name="connsiteY20" fmla="*/ 986050 h 989462"/>
                <a:gd name="connsiteX21" fmla="*/ 341194 w 1044468"/>
                <a:gd name="connsiteY21" fmla="*/ 955343 h 989462"/>
                <a:gd name="connsiteX22" fmla="*/ 317310 w 1044468"/>
                <a:gd name="connsiteY22" fmla="*/ 931459 h 989462"/>
                <a:gd name="connsiteX23" fmla="*/ 310486 w 1044468"/>
                <a:gd name="connsiteY23" fmla="*/ 921223 h 989462"/>
                <a:gd name="connsiteX24" fmla="*/ 286603 w 1044468"/>
                <a:gd name="connsiteY24" fmla="*/ 907576 h 989462"/>
                <a:gd name="connsiteX25" fmla="*/ 242248 w 1044468"/>
                <a:gd name="connsiteY25" fmla="*/ 883692 h 989462"/>
                <a:gd name="connsiteX26" fmla="*/ 208128 w 1044468"/>
                <a:gd name="connsiteY26" fmla="*/ 863220 h 989462"/>
                <a:gd name="connsiteX27" fmla="*/ 197892 w 1044468"/>
                <a:gd name="connsiteY27" fmla="*/ 852985 h 989462"/>
                <a:gd name="connsiteX28" fmla="*/ 187657 w 1044468"/>
                <a:gd name="connsiteY28" fmla="*/ 846161 h 989462"/>
                <a:gd name="connsiteX29" fmla="*/ 177421 w 1044468"/>
                <a:gd name="connsiteY29" fmla="*/ 842749 h 989462"/>
                <a:gd name="connsiteX30" fmla="*/ 75063 w 1044468"/>
                <a:gd name="connsiteY30" fmla="*/ 835925 h 989462"/>
                <a:gd name="connsiteX31" fmla="*/ 64827 w 1044468"/>
                <a:gd name="connsiteY31" fmla="*/ 829101 h 989462"/>
                <a:gd name="connsiteX32" fmla="*/ 47767 w 1044468"/>
                <a:gd name="connsiteY32" fmla="*/ 812041 h 989462"/>
                <a:gd name="connsiteX33" fmla="*/ 37531 w 1044468"/>
                <a:gd name="connsiteY33" fmla="*/ 808629 h 989462"/>
                <a:gd name="connsiteX34" fmla="*/ 30707 w 1044468"/>
                <a:gd name="connsiteY34" fmla="*/ 798394 h 989462"/>
                <a:gd name="connsiteX35" fmla="*/ 20472 w 1044468"/>
                <a:gd name="connsiteY35" fmla="*/ 784746 h 989462"/>
                <a:gd name="connsiteX36" fmla="*/ 13648 w 1044468"/>
                <a:gd name="connsiteY36" fmla="*/ 757450 h 989462"/>
                <a:gd name="connsiteX37" fmla="*/ 3412 w 1044468"/>
                <a:gd name="connsiteY37" fmla="*/ 719919 h 989462"/>
                <a:gd name="connsiteX38" fmla="*/ 0 w 1044468"/>
                <a:gd name="connsiteY38" fmla="*/ 706271 h 989462"/>
                <a:gd name="connsiteX39" fmla="*/ 3412 w 1044468"/>
                <a:gd name="connsiteY39" fmla="*/ 682388 h 989462"/>
                <a:gd name="connsiteX40" fmla="*/ 6824 w 1044468"/>
                <a:gd name="connsiteY40" fmla="*/ 668740 h 989462"/>
                <a:gd name="connsiteX41" fmla="*/ 10236 w 1044468"/>
                <a:gd name="connsiteY41" fmla="*/ 562970 h 989462"/>
                <a:gd name="connsiteX42" fmla="*/ 40943 w 1044468"/>
                <a:gd name="connsiteY42" fmla="*/ 528850 h 989462"/>
                <a:gd name="connsiteX43" fmla="*/ 51179 w 1044468"/>
                <a:gd name="connsiteY43" fmla="*/ 518614 h 989462"/>
                <a:gd name="connsiteX44" fmla="*/ 95534 w 1044468"/>
                <a:gd name="connsiteY44" fmla="*/ 491319 h 989462"/>
                <a:gd name="connsiteX45" fmla="*/ 102358 w 1044468"/>
                <a:gd name="connsiteY45" fmla="*/ 470847 h 989462"/>
                <a:gd name="connsiteX46" fmla="*/ 105770 w 1044468"/>
                <a:gd name="connsiteY46" fmla="*/ 457200 h 989462"/>
                <a:gd name="connsiteX47" fmla="*/ 95534 w 1044468"/>
                <a:gd name="connsiteY47" fmla="*/ 419668 h 989462"/>
                <a:gd name="connsiteX48" fmla="*/ 92122 w 1044468"/>
                <a:gd name="connsiteY48" fmla="*/ 392373 h 989462"/>
                <a:gd name="connsiteX49" fmla="*/ 92122 w 1044468"/>
                <a:gd name="connsiteY49" fmla="*/ 344605 h 989462"/>
                <a:gd name="connsiteX50" fmla="*/ 98946 w 1044468"/>
                <a:gd name="connsiteY50" fmla="*/ 334370 h 989462"/>
                <a:gd name="connsiteX51" fmla="*/ 119418 w 1044468"/>
                <a:gd name="connsiteY51" fmla="*/ 303662 h 989462"/>
                <a:gd name="connsiteX52" fmla="*/ 129654 w 1044468"/>
                <a:gd name="connsiteY52" fmla="*/ 272955 h 989462"/>
                <a:gd name="connsiteX53" fmla="*/ 133066 w 1044468"/>
                <a:gd name="connsiteY53" fmla="*/ 262719 h 989462"/>
                <a:gd name="connsiteX54" fmla="*/ 136477 w 1044468"/>
                <a:gd name="connsiteY54" fmla="*/ 249071 h 989462"/>
                <a:gd name="connsiteX55" fmla="*/ 167185 w 1044468"/>
                <a:gd name="connsiteY55" fmla="*/ 194480 h 989462"/>
                <a:gd name="connsiteX56" fmla="*/ 187657 w 1044468"/>
                <a:gd name="connsiteY56" fmla="*/ 163773 h 989462"/>
                <a:gd name="connsiteX57" fmla="*/ 187657 w 1044468"/>
                <a:gd name="connsiteY57" fmla="*/ 58003 h 989462"/>
                <a:gd name="connsiteX58" fmla="*/ 191069 w 1044468"/>
                <a:gd name="connsiteY58" fmla="*/ 27295 h 989462"/>
                <a:gd name="connsiteX59" fmla="*/ 218364 w 1044468"/>
                <a:gd name="connsiteY59" fmla="*/ 13647 h 989462"/>
                <a:gd name="connsiteX60" fmla="*/ 286603 w 1044468"/>
                <a:gd name="connsiteY60" fmla="*/ 23883 h 989462"/>
                <a:gd name="connsiteX61" fmla="*/ 300251 w 1044468"/>
                <a:gd name="connsiteY61" fmla="*/ 34119 h 989462"/>
                <a:gd name="connsiteX62" fmla="*/ 341194 w 1044468"/>
                <a:gd name="connsiteY62" fmla="*/ 47767 h 989462"/>
                <a:gd name="connsiteX63" fmla="*/ 436728 w 1044468"/>
                <a:gd name="connsiteY63" fmla="*/ 51179 h 989462"/>
                <a:gd name="connsiteX64" fmla="*/ 457200 w 1044468"/>
                <a:gd name="connsiteY64" fmla="*/ 61414 h 989462"/>
                <a:gd name="connsiteX65" fmla="*/ 484495 w 1044468"/>
                <a:gd name="connsiteY65" fmla="*/ 71650 h 989462"/>
                <a:gd name="connsiteX66" fmla="*/ 504967 w 1044468"/>
                <a:gd name="connsiteY66" fmla="*/ 68238 h 989462"/>
                <a:gd name="connsiteX67" fmla="*/ 532263 w 1044468"/>
                <a:gd name="connsiteY67" fmla="*/ 54591 h 989462"/>
                <a:gd name="connsiteX68" fmla="*/ 545910 w 1044468"/>
                <a:gd name="connsiteY68" fmla="*/ 44355 h 989462"/>
                <a:gd name="connsiteX69" fmla="*/ 583442 w 1044468"/>
                <a:gd name="connsiteY69" fmla="*/ 10235 h 989462"/>
                <a:gd name="connsiteX70" fmla="*/ 593677 w 1044468"/>
                <a:gd name="connsiteY70" fmla="*/ 6823 h 989462"/>
                <a:gd name="connsiteX71" fmla="*/ 620973 w 1044468"/>
                <a:gd name="connsiteY71" fmla="*/ 0 h 989462"/>
                <a:gd name="connsiteX72" fmla="*/ 641445 w 1044468"/>
                <a:gd name="connsiteY72" fmla="*/ 3411 h 989462"/>
                <a:gd name="connsiteX73" fmla="*/ 675564 w 1044468"/>
                <a:gd name="connsiteY73" fmla="*/ 23883 h 989462"/>
                <a:gd name="connsiteX74" fmla="*/ 696036 w 1044468"/>
                <a:gd name="connsiteY74" fmla="*/ 34119 h 989462"/>
                <a:gd name="connsiteX75" fmla="*/ 699448 w 1044468"/>
                <a:gd name="connsiteY75" fmla="*/ 47767 h 989462"/>
                <a:gd name="connsiteX76" fmla="*/ 716507 w 1044468"/>
                <a:gd name="connsiteY76" fmla="*/ 92122 h 989462"/>
                <a:gd name="connsiteX77" fmla="*/ 719919 w 1044468"/>
                <a:gd name="connsiteY77" fmla="*/ 105770 h 989462"/>
                <a:gd name="connsiteX78" fmla="*/ 730155 w 1044468"/>
                <a:gd name="connsiteY78" fmla="*/ 109182 h 989462"/>
                <a:gd name="connsiteX79" fmla="*/ 760863 w 1044468"/>
                <a:gd name="connsiteY79" fmla="*/ 119417 h 989462"/>
                <a:gd name="connsiteX80" fmla="*/ 788158 w 1044468"/>
                <a:gd name="connsiteY80" fmla="*/ 136477 h 989462"/>
                <a:gd name="connsiteX81" fmla="*/ 798394 w 1044468"/>
                <a:gd name="connsiteY81" fmla="*/ 150125 h 989462"/>
                <a:gd name="connsiteX82" fmla="*/ 805218 w 1044468"/>
                <a:gd name="connsiteY82" fmla="*/ 174008 h 989462"/>
                <a:gd name="connsiteX83" fmla="*/ 815454 w 1044468"/>
                <a:gd name="connsiteY83" fmla="*/ 180832 h 989462"/>
                <a:gd name="connsiteX84" fmla="*/ 818866 w 1044468"/>
                <a:gd name="connsiteY84" fmla="*/ 191068 h 989462"/>
                <a:gd name="connsiteX85" fmla="*/ 829101 w 1044468"/>
                <a:gd name="connsiteY85" fmla="*/ 201304 h 989462"/>
                <a:gd name="connsiteX86" fmla="*/ 852985 w 1044468"/>
                <a:gd name="connsiteY86" fmla="*/ 232011 h 989462"/>
                <a:gd name="connsiteX87" fmla="*/ 859809 w 1044468"/>
                <a:gd name="connsiteY87" fmla="*/ 245659 h 989462"/>
                <a:gd name="connsiteX88" fmla="*/ 863221 w 1044468"/>
                <a:gd name="connsiteY88" fmla="*/ 255895 h 989462"/>
                <a:gd name="connsiteX89" fmla="*/ 873457 w 1044468"/>
                <a:gd name="connsiteY89" fmla="*/ 279779 h 989462"/>
                <a:gd name="connsiteX90" fmla="*/ 876869 w 1044468"/>
                <a:gd name="connsiteY90" fmla="*/ 303662 h 989462"/>
                <a:gd name="connsiteX91" fmla="*/ 890516 w 1044468"/>
                <a:gd name="connsiteY91" fmla="*/ 344605 h 989462"/>
                <a:gd name="connsiteX92" fmla="*/ 907576 w 1044468"/>
                <a:gd name="connsiteY92" fmla="*/ 365077 h 989462"/>
                <a:gd name="connsiteX93" fmla="*/ 917812 w 1044468"/>
                <a:gd name="connsiteY93" fmla="*/ 382137 h 989462"/>
                <a:gd name="connsiteX94" fmla="*/ 938283 w 1044468"/>
                <a:gd name="connsiteY94" fmla="*/ 392373 h 989462"/>
                <a:gd name="connsiteX95" fmla="*/ 934872 w 1044468"/>
                <a:gd name="connsiteY95" fmla="*/ 453788 h 989462"/>
                <a:gd name="connsiteX96" fmla="*/ 938283 w 1044468"/>
                <a:gd name="connsiteY96" fmla="*/ 474259 h 989462"/>
                <a:gd name="connsiteX97" fmla="*/ 941695 w 1044468"/>
                <a:gd name="connsiteY97" fmla="*/ 542498 h 989462"/>
                <a:gd name="connsiteX98" fmla="*/ 945107 w 1044468"/>
                <a:gd name="connsiteY98" fmla="*/ 552734 h 989462"/>
                <a:gd name="connsiteX99" fmla="*/ 951931 w 1044468"/>
                <a:gd name="connsiteY99" fmla="*/ 562970 h 989462"/>
                <a:gd name="connsiteX100" fmla="*/ 962167 w 1044468"/>
                <a:gd name="connsiteY100" fmla="*/ 569794 h 989462"/>
                <a:gd name="connsiteX101" fmla="*/ 1016758 w 1044468"/>
                <a:gd name="connsiteY101" fmla="*/ 566382 h 989462"/>
                <a:gd name="connsiteX102" fmla="*/ 1037230 w 1044468"/>
                <a:gd name="connsiteY102" fmla="*/ 559558 h 989462"/>
                <a:gd name="connsiteX103" fmla="*/ 1033818 w 1044468"/>
                <a:gd name="connsiteY103" fmla="*/ 699447 h 989462"/>
                <a:gd name="connsiteX104" fmla="*/ 1023582 w 1044468"/>
                <a:gd name="connsiteY104" fmla="*/ 723331 h 989462"/>
                <a:gd name="connsiteX105" fmla="*/ 1003110 w 1044468"/>
                <a:gd name="connsiteY105" fmla="*/ 736979 h 989462"/>
                <a:gd name="connsiteX106" fmla="*/ 975815 w 1044468"/>
                <a:gd name="connsiteY106" fmla="*/ 750626 h 989462"/>
                <a:gd name="connsiteX107" fmla="*/ 938283 w 1044468"/>
                <a:gd name="connsiteY107" fmla="*/ 774510 h 989462"/>
                <a:gd name="connsiteX108" fmla="*/ 924636 w 1044468"/>
                <a:gd name="connsiteY108" fmla="*/ 784746 h 989462"/>
                <a:gd name="connsiteX109" fmla="*/ 890516 w 1044468"/>
                <a:gd name="connsiteY109" fmla="*/ 829101 h 9894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</a:cxnLst>
              <a:rect l="l" t="t" r="r" b="b"/>
              <a:pathLst>
                <a:path w="1044468" h="989462">
                  <a:moveTo>
                    <a:pt x="890516" y="829101"/>
                  </a:moveTo>
                  <a:cubicBezTo>
                    <a:pt x="881986" y="835925"/>
                    <a:pt x="879256" y="825689"/>
                    <a:pt x="873457" y="825689"/>
                  </a:cubicBezTo>
                  <a:cubicBezTo>
                    <a:pt x="858628" y="825689"/>
                    <a:pt x="843676" y="826368"/>
                    <a:pt x="829101" y="829101"/>
                  </a:cubicBezTo>
                  <a:cubicBezTo>
                    <a:pt x="825071" y="829857"/>
                    <a:pt x="822016" y="833300"/>
                    <a:pt x="818866" y="835925"/>
                  </a:cubicBezTo>
                  <a:cubicBezTo>
                    <a:pt x="806380" y="846330"/>
                    <a:pt x="810754" y="844467"/>
                    <a:pt x="801806" y="856397"/>
                  </a:cubicBezTo>
                  <a:cubicBezTo>
                    <a:pt x="797437" y="862223"/>
                    <a:pt x="792707" y="867770"/>
                    <a:pt x="788158" y="873456"/>
                  </a:cubicBezTo>
                  <a:cubicBezTo>
                    <a:pt x="785883" y="879143"/>
                    <a:pt x="782711" y="884548"/>
                    <a:pt x="781334" y="890516"/>
                  </a:cubicBezTo>
                  <a:cubicBezTo>
                    <a:pt x="777987" y="905019"/>
                    <a:pt x="775015" y="958513"/>
                    <a:pt x="774510" y="965579"/>
                  </a:cubicBezTo>
                  <a:cubicBezTo>
                    <a:pt x="764274" y="963304"/>
                    <a:pt x="753677" y="962282"/>
                    <a:pt x="743803" y="958755"/>
                  </a:cubicBezTo>
                  <a:cubicBezTo>
                    <a:pt x="737558" y="956524"/>
                    <a:pt x="732675" y="951485"/>
                    <a:pt x="726743" y="948519"/>
                  </a:cubicBezTo>
                  <a:cubicBezTo>
                    <a:pt x="709084" y="939689"/>
                    <a:pt x="706729" y="941273"/>
                    <a:pt x="685800" y="938283"/>
                  </a:cubicBezTo>
                  <a:cubicBezTo>
                    <a:pt x="676701" y="939420"/>
                    <a:pt x="667549" y="940188"/>
                    <a:pt x="658504" y="941695"/>
                  </a:cubicBezTo>
                  <a:cubicBezTo>
                    <a:pt x="653879" y="942466"/>
                    <a:pt x="648907" y="942744"/>
                    <a:pt x="644857" y="945107"/>
                  </a:cubicBezTo>
                  <a:cubicBezTo>
                    <a:pt x="608427" y="966359"/>
                    <a:pt x="630329" y="962418"/>
                    <a:pt x="607325" y="968991"/>
                  </a:cubicBezTo>
                  <a:cubicBezTo>
                    <a:pt x="602816" y="970279"/>
                    <a:pt x="598226" y="971266"/>
                    <a:pt x="593677" y="972403"/>
                  </a:cubicBezTo>
                  <a:cubicBezTo>
                    <a:pt x="584579" y="971266"/>
                    <a:pt x="575426" y="970498"/>
                    <a:pt x="566382" y="968991"/>
                  </a:cubicBezTo>
                  <a:cubicBezTo>
                    <a:pt x="557813" y="967563"/>
                    <a:pt x="550611" y="964871"/>
                    <a:pt x="542498" y="962167"/>
                  </a:cubicBezTo>
                  <a:cubicBezTo>
                    <a:pt x="530226" y="964212"/>
                    <a:pt x="522483" y="964409"/>
                    <a:pt x="511791" y="968991"/>
                  </a:cubicBezTo>
                  <a:cubicBezTo>
                    <a:pt x="493838" y="976684"/>
                    <a:pt x="491628" y="982594"/>
                    <a:pt x="467436" y="986050"/>
                  </a:cubicBezTo>
                  <a:lnTo>
                    <a:pt x="443552" y="989462"/>
                  </a:lnTo>
                  <a:cubicBezTo>
                    <a:pt x="420806" y="988325"/>
                    <a:pt x="397802" y="989648"/>
                    <a:pt x="375313" y="986050"/>
                  </a:cubicBezTo>
                  <a:cubicBezTo>
                    <a:pt x="360388" y="983662"/>
                    <a:pt x="349439" y="964275"/>
                    <a:pt x="341194" y="955343"/>
                  </a:cubicBezTo>
                  <a:cubicBezTo>
                    <a:pt x="333557" y="947070"/>
                    <a:pt x="323555" y="940827"/>
                    <a:pt x="317310" y="931459"/>
                  </a:cubicBezTo>
                  <a:cubicBezTo>
                    <a:pt x="315035" y="928047"/>
                    <a:pt x="313723" y="923741"/>
                    <a:pt x="310486" y="921223"/>
                  </a:cubicBezTo>
                  <a:cubicBezTo>
                    <a:pt x="303248" y="915594"/>
                    <a:pt x="294676" y="911923"/>
                    <a:pt x="286603" y="907576"/>
                  </a:cubicBezTo>
                  <a:cubicBezTo>
                    <a:pt x="224522" y="874148"/>
                    <a:pt x="312906" y="924069"/>
                    <a:pt x="242248" y="883692"/>
                  </a:cubicBezTo>
                  <a:cubicBezTo>
                    <a:pt x="221861" y="856510"/>
                    <a:pt x="245026" y="881668"/>
                    <a:pt x="208128" y="863220"/>
                  </a:cubicBezTo>
                  <a:cubicBezTo>
                    <a:pt x="203812" y="861062"/>
                    <a:pt x="201599" y="856074"/>
                    <a:pt x="197892" y="852985"/>
                  </a:cubicBezTo>
                  <a:cubicBezTo>
                    <a:pt x="194742" y="850360"/>
                    <a:pt x="191325" y="847995"/>
                    <a:pt x="187657" y="846161"/>
                  </a:cubicBezTo>
                  <a:cubicBezTo>
                    <a:pt x="184440" y="844553"/>
                    <a:pt x="180910" y="843621"/>
                    <a:pt x="177421" y="842749"/>
                  </a:cubicBezTo>
                  <a:cubicBezTo>
                    <a:pt x="143164" y="834185"/>
                    <a:pt x="113627" y="837468"/>
                    <a:pt x="75063" y="835925"/>
                  </a:cubicBezTo>
                  <a:cubicBezTo>
                    <a:pt x="71651" y="833650"/>
                    <a:pt x="67913" y="831801"/>
                    <a:pt x="64827" y="829101"/>
                  </a:cubicBezTo>
                  <a:cubicBezTo>
                    <a:pt x="58775" y="823805"/>
                    <a:pt x="54201" y="816866"/>
                    <a:pt x="47767" y="812041"/>
                  </a:cubicBezTo>
                  <a:cubicBezTo>
                    <a:pt x="44890" y="809883"/>
                    <a:pt x="40943" y="809766"/>
                    <a:pt x="37531" y="808629"/>
                  </a:cubicBezTo>
                  <a:cubicBezTo>
                    <a:pt x="35256" y="805217"/>
                    <a:pt x="33090" y="801731"/>
                    <a:pt x="30707" y="798394"/>
                  </a:cubicBezTo>
                  <a:cubicBezTo>
                    <a:pt x="27402" y="793767"/>
                    <a:pt x="23293" y="789683"/>
                    <a:pt x="20472" y="784746"/>
                  </a:cubicBezTo>
                  <a:cubicBezTo>
                    <a:pt x="17146" y="778925"/>
                    <a:pt x="14669" y="762046"/>
                    <a:pt x="13648" y="757450"/>
                  </a:cubicBezTo>
                  <a:cubicBezTo>
                    <a:pt x="10562" y="743565"/>
                    <a:pt x="7401" y="734547"/>
                    <a:pt x="3412" y="719919"/>
                  </a:cubicBezTo>
                  <a:cubicBezTo>
                    <a:pt x="2178" y="715395"/>
                    <a:pt x="1137" y="710820"/>
                    <a:pt x="0" y="706271"/>
                  </a:cubicBezTo>
                  <a:cubicBezTo>
                    <a:pt x="1137" y="698310"/>
                    <a:pt x="1973" y="690300"/>
                    <a:pt x="3412" y="682388"/>
                  </a:cubicBezTo>
                  <a:cubicBezTo>
                    <a:pt x="4251" y="677774"/>
                    <a:pt x="6556" y="673422"/>
                    <a:pt x="6824" y="668740"/>
                  </a:cubicBezTo>
                  <a:cubicBezTo>
                    <a:pt x="8836" y="633522"/>
                    <a:pt x="4735" y="597813"/>
                    <a:pt x="10236" y="562970"/>
                  </a:cubicBezTo>
                  <a:cubicBezTo>
                    <a:pt x="12978" y="545605"/>
                    <a:pt x="29711" y="538477"/>
                    <a:pt x="40943" y="528850"/>
                  </a:cubicBezTo>
                  <a:cubicBezTo>
                    <a:pt x="44607" y="525710"/>
                    <a:pt x="47108" y="521205"/>
                    <a:pt x="51179" y="518614"/>
                  </a:cubicBezTo>
                  <a:cubicBezTo>
                    <a:pt x="113162" y="479171"/>
                    <a:pt x="50360" y="527458"/>
                    <a:pt x="95534" y="491319"/>
                  </a:cubicBezTo>
                  <a:cubicBezTo>
                    <a:pt x="97809" y="484495"/>
                    <a:pt x="100291" y="477737"/>
                    <a:pt x="102358" y="470847"/>
                  </a:cubicBezTo>
                  <a:cubicBezTo>
                    <a:pt x="103705" y="466356"/>
                    <a:pt x="106390" y="461848"/>
                    <a:pt x="105770" y="457200"/>
                  </a:cubicBezTo>
                  <a:cubicBezTo>
                    <a:pt x="104056" y="444346"/>
                    <a:pt x="98946" y="432179"/>
                    <a:pt x="95534" y="419668"/>
                  </a:cubicBezTo>
                  <a:cubicBezTo>
                    <a:pt x="94397" y="410570"/>
                    <a:pt x="93419" y="401450"/>
                    <a:pt x="92122" y="392373"/>
                  </a:cubicBezTo>
                  <a:cubicBezTo>
                    <a:pt x="88973" y="370327"/>
                    <a:pt x="85506" y="368863"/>
                    <a:pt x="92122" y="344605"/>
                  </a:cubicBezTo>
                  <a:cubicBezTo>
                    <a:pt x="93201" y="340649"/>
                    <a:pt x="96486" y="337650"/>
                    <a:pt x="98946" y="334370"/>
                  </a:cubicBezTo>
                  <a:cubicBezTo>
                    <a:pt x="113365" y="315146"/>
                    <a:pt x="111018" y="322561"/>
                    <a:pt x="119418" y="303662"/>
                  </a:cubicBezTo>
                  <a:cubicBezTo>
                    <a:pt x="128829" y="282487"/>
                    <a:pt x="124109" y="292362"/>
                    <a:pt x="129654" y="272955"/>
                  </a:cubicBezTo>
                  <a:cubicBezTo>
                    <a:pt x="130642" y="269497"/>
                    <a:pt x="132078" y="266177"/>
                    <a:pt x="133066" y="262719"/>
                  </a:cubicBezTo>
                  <a:cubicBezTo>
                    <a:pt x="134354" y="258210"/>
                    <a:pt x="134630" y="253381"/>
                    <a:pt x="136477" y="249071"/>
                  </a:cubicBezTo>
                  <a:cubicBezTo>
                    <a:pt x="145807" y="227301"/>
                    <a:pt x="153835" y="212836"/>
                    <a:pt x="167185" y="194480"/>
                  </a:cubicBezTo>
                  <a:cubicBezTo>
                    <a:pt x="187376" y="166717"/>
                    <a:pt x="175225" y="188635"/>
                    <a:pt x="187657" y="163773"/>
                  </a:cubicBezTo>
                  <a:cubicBezTo>
                    <a:pt x="195359" y="79051"/>
                    <a:pt x="187657" y="183220"/>
                    <a:pt x="187657" y="58003"/>
                  </a:cubicBezTo>
                  <a:cubicBezTo>
                    <a:pt x="187657" y="47704"/>
                    <a:pt x="185207" y="35763"/>
                    <a:pt x="191069" y="27295"/>
                  </a:cubicBezTo>
                  <a:cubicBezTo>
                    <a:pt x="196859" y="18931"/>
                    <a:pt x="209266" y="18196"/>
                    <a:pt x="218364" y="13647"/>
                  </a:cubicBezTo>
                  <a:cubicBezTo>
                    <a:pt x="241110" y="17059"/>
                    <a:pt x="264289" y="18304"/>
                    <a:pt x="286603" y="23883"/>
                  </a:cubicBezTo>
                  <a:cubicBezTo>
                    <a:pt x="292120" y="25262"/>
                    <a:pt x="295259" y="31396"/>
                    <a:pt x="300251" y="34119"/>
                  </a:cubicBezTo>
                  <a:cubicBezTo>
                    <a:pt x="319581" y="44663"/>
                    <a:pt x="322258" y="43980"/>
                    <a:pt x="341194" y="47767"/>
                  </a:cubicBezTo>
                  <a:cubicBezTo>
                    <a:pt x="389025" y="42452"/>
                    <a:pt x="371093" y="42229"/>
                    <a:pt x="436728" y="51179"/>
                  </a:cubicBezTo>
                  <a:cubicBezTo>
                    <a:pt x="448518" y="52787"/>
                    <a:pt x="446634" y="56132"/>
                    <a:pt x="457200" y="61414"/>
                  </a:cubicBezTo>
                  <a:cubicBezTo>
                    <a:pt x="465359" y="65493"/>
                    <a:pt x="475637" y="68697"/>
                    <a:pt x="484495" y="71650"/>
                  </a:cubicBezTo>
                  <a:cubicBezTo>
                    <a:pt x="491319" y="70513"/>
                    <a:pt x="498293" y="70058"/>
                    <a:pt x="504967" y="68238"/>
                  </a:cubicBezTo>
                  <a:cubicBezTo>
                    <a:pt x="517345" y="64862"/>
                    <a:pt x="522614" y="61483"/>
                    <a:pt x="532263" y="54591"/>
                  </a:cubicBezTo>
                  <a:cubicBezTo>
                    <a:pt x="536890" y="51286"/>
                    <a:pt x="541889" y="48376"/>
                    <a:pt x="545910" y="44355"/>
                  </a:cubicBezTo>
                  <a:cubicBezTo>
                    <a:pt x="563283" y="26981"/>
                    <a:pt x="538884" y="25089"/>
                    <a:pt x="583442" y="10235"/>
                  </a:cubicBezTo>
                  <a:cubicBezTo>
                    <a:pt x="586854" y="9098"/>
                    <a:pt x="590207" y="7769"/>
                    <a:pt x="593677" y="6823"/>
                  </a:cubicBezTo>
                  <a:cubicBezTo>
                    <a:pt x="602725" y="4355"/>
                    <a:pt x="620973" y="0"/>
                    <a:pt x="620973" y="0"/>
                  </a:cubicBezTo>
                  <a:cubicBezTo>
                    <a:pt x="627797" y="1137"/>
                    <a:pt x="635107" y="638"/>
                    <a:pt x="641445" y="3411"/>
                  </a:cubicBezTo>
                  <a:cubicBezTo>
                    <a:pt x="653596" y="8727"/>
                    <a:pt x="663701" y="17952"/>
                    <a:pt x="675564" y="23883"/>
                  </a:cubicBezTo>
                  <a:lnTo>
                    <a:pt x="696036" y="34119"/>
                  </a:lnTo>
                  <a:cubicBezTo>
                    <a:pt x="697173" y="38668"/>
                    <a:pt x="697801" y="43376"/>
                    <a:pt x="699448" y="47767"/>
                  </a:cubicBezTo>
                  <a:cubicBezTo>
                    <a:pt x="712737" y="83203"/>
                    <a:pt x="701186" y="30839"/>
                    <a:pt x="716507" y="92122"/>
                  </a:cubicBezTo>
                  <a:cubicBezTo>
                    <a:pt x="717644" y="96671"/>
                    <a:pt x="716990" y="102108"/>
                    <a:pt x="719919" y="105770"/>
                  </a:cubicBezTo>
                  <a:cubicBezTo>
                    <a:pt x="722166" y="108578"/>
                    <a:pt x="726787" y="107919"/>
                    <a:pt x="730155" y="109182"/>
                  </a:cubicBezTo>
                  <a:cubicBezTo>
                    <a:pt x="755849" y="118816"/>
                    <a:pt x="737996" y="113700"/>
                    <a:pt x="760863" y="119417"/>
                  </a:cubicBezTo>
                  <a:cubicBezTo>
                    <a:pt x="771673" y="124822"/>
                    <a:pt x="779300" y="127619"/>
                    <a:pt x="788158" y="136477"/>
                  </a:cubicBezTo>
                  <a:cubicBezTo>
                    <a:pt x="792179" y="140498"/>
                    <a:pt x="794982" y="145576"/>
                    <a:pt x="798394" y="150125"/>
                  </a:cubicBezTo>
                  <a:cubicBezTo>
                    <a:pt x="800669" y="158086"/>
                    <a:pt x="801197" y="166770"/>
                    <a:pt x="805218" y="174008"/>
                  </a:cubicBezTo>
                  <a:cubicBezTo>
                    <a:pt x="807210" y="177593"/>
                    <a:pt x="812892" y="177630"/>
                    <a:pt x="815454" y="180832"/>
                  </a:cubicBezTo>
                  <a:cubicBezTo>
                    <a:pt x="817701" y="183640"/>
                    <a:pt x="816871" y="188075"/>
                    <a:pt x="818866" y="191068"/>
                  </a:cubicBezTo>
                  <a:cubicBezTo>
                    <a:pt x="821542" y="195083"/>
                    <a:pt x="826139" y="197495"/>
                    <a:pt x="829101" y="201304"/>
                  </a:cubicBezTo>
                  <a:cubicBezTo>
                    <a:pt x="857659" y="238023"/>
                    <a:pt x="829752" y="208780"/>
                    <a:pt x="852985" y="232011"/>
                  </a:cubicBezTo>
                  <a:cubicBezTo>
                    <a:pt x="855260" y="236560"/>
                    <a:pt x="857805" y="240984"/>
                    <a:pt x="859809" y="245659"/>
                  </a:cubicBezTo>
                  <a:cubicBezTo>
                    <a:pt x="861226" y="248965"/>
                    <a:pt x="861804" y="252589"/>
                    <a:pt x="863221" y="255895"/>
                  </a:cubicBezTo>
                  <a:cubicBezTo>
                    <a:pt x="875870" y="285409"/>
                    <a:pt x="865455" y="255774"/>
                    <a:pt x="873457" y="279779"/>
                  </a:cubicBezTo>
                  <a:cubicBezTo>
                    <a:pt x="874594" y="287740"/>
                    <a:pt x="875184" y="295799"/>
                    <a:pt x="876869" y="303662"/>
                  </a:cubicBezTo>
                  <a:cubicBezTo>
                    <a:pt x="879146" y="314288"/>
                    <a:pt x="885224" y="334021"/>
                    <a:pt x="890516" y="344605"/>
                  </a:cubicBezTo>
                  <a:cubicBezTo>
                    <a:pt x="898474" y="360520"/>
                    <a:pt x="896256" y="349984"/>
                    <a:pt x="907576" y="365077"/>
                  </a:cubicBezTo>
                  <a:cubicBezTo>
                    <a:pt x="911555" y="370382"/>
                    <a:pt x="913496" y="377102"/>
                    <a:pt x="917812" y="382137"/>
                  </a:cubicBezTo>
                  <a:cubicBezTo>
                    <a:pt x="923103" y="388310"/>
                    <a:pt x="931119" y="389985"/>
                    <a:pt x="938283" y="392373"/>
                  </a:cubicBezTo>
                  <a:cubicBezTo>
                    <a:pt x="946778" y="426352"/>
                    <a:pt x="938303" y="385161"/>
                    <a:pt x="934872" y="453788"/>
                  </a:cubicBezTo>
                  <a:cubicBezTo>
                    <a:pt x="934527" y="460697"/>
                    <a:pt x="937146" y="467435"/>
                    <a:pt x="938283" y="474259"/>
                  </a:cubicBezTo>
                  <a:cubicBezTo>
                    <a:pt x="939420" y="497005"/>
                    <a:pt x="939722" y="519809"/>
                    <a:pt x="941695" y="542498"/>
                  </a:cubicBezTo>
                  <a:cubicBezTo>
                    <a:pt x="942007" y="546081"/>
                    <a:pt x="943499" y="549517"/>
                    <a:pt x="945107" y="552734"/>
                  </a:cubicBezTo>
                  <a:cubicBezTo>
                    <a:pt x="946941" y="556402"/>
                    <a:pt x="949031" y="560070"/>
                    <a:pt x="951931" y="562970"/>
                  </a:cubicBezTo>
                  <a:cubicBezTo>
                    <a:pt x="954831" y="565870"/>
                    <a:pt x="958755" y="567519"/>
                    <a:pt x="962167" y="569794"/>
                  </a:cubicBezTo>
                  <a:cubicBezTo>
                    <a:pt x="980364" y="568657"/>
                    <a:pt x="998693" y="568845"/>
                    <a:pt x="1016758" y="566382"/>
                  </a:cubicBezTo>
                  <a:cubicBezTo>
                    <a:pt x="1023885" y="565410"/>
                    <a:pt x="1037230" y="559558"/>
                    <a:pt x="1037230" y="559558"/>
                  </a:cubicBezTo>
                  <a:cubicBezTo>
                    <a:pt x="1050629" y="613150"/>
                    <a:pt x="1043005" y="576960"/>
                    <a:pt x="1033818" y="699447"/>
                  </a:cubicBezTo>
                  <a:cubicBezTo>
                    <a:pt x="1033487" y="703856"/>
                    <a:pt x="1025382" y="721531"/>
                    <a:pt x="1023582" y="723331"/>
                  </a:cubicBezTo>
                  <a:cubicBezTo>
                    <a:pt x="1017783" y="729130"/>
                    <a:pt x="1008910" y="731180"/>
                    <a:pt x="1003110" y="736979"/>
                  </a:cubicBezTo>
                  <a:cubicBezTo>
                    <a:pt x="988773" y="751314"/>
                    <a:pt x="997605" y="746268"/>
                    <a:pt x="975815" y="750626"/>
                  </a:cubicBezTo>
                  <a:cubicBezTo>
                    <a:pt x="963304" y="758587"/>
                    <a:pt x="950146" y="765612"/>
                    <a:pt x="938283" y="774510"/>
                  </a:cubicBezTo>
                  <a:cubicBezTo>
                    <a:pt x="933734" y="777922"/>
                    <a:pt x="929573" y="781925"/>
                    <a:pt x="924636" y="784746"/>
                  </a:cubicBezTo>
                  <a:cubicBezTo>
                    <a:pt x="903965" y="796559"/>
                    <a:pt x="899046" y="822277"/>
                    <a:pt x="890516" y="829101"/>
                  </a:cubicBezTo>
                  <a:close/>
                </a:path>
              </a:pathLst>
            </a:custGeom>
            <a:noFill/>
            <a:ln w="19050">
              <a:solidFill>
                <a:schemeClr val="bg1">
                  <a:lumMod val="85000"/>
                </a:schemeClr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8426B3AB-6F16-3A19-AA26-3EA86CE17279}"/>
              </a:ext>
            </a:extLst>
          </p:cNvPr>
          <p:cNvGrpSpPr>
            <a:grpSpLocks noChangeAspect="1"/>
          </p:cNvGrpSpPr>
          <p:nvPr/>
        </p:nvGrpSpPr>
        <p:grpSpPr>
          <a:xfrm>
            <a:off x="4174963" y="691183"/>
            <a:ext cx="1080000" cy="1080000"/>
            <a:chOff x="2442521" y="4272556"/>
            <a:chExt cx="4315968" cy="4315968"/>
          </a:xfrm>
        </p:grpSpPr>
        <p:pic>
          <p:nvPicPr>
            <p:cNvPr id="130" name="図 129">
              <a:extLst>
                <a:ext uri="{FF2B5EF4-FFF2-40B4-BE49-F238E27FC236}">
                  <a16:creationId xmlns:a16="http://schemas.microsoft.com/office/drawing/2014/main" id="{2AA5E793-E8E4-49E5-7C00-D141E1FF2F6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2521" y="4272556"/>
              <a:ext cx="4315968" cy="4315968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554AE156-8BDD-A9AB-1CA4-1C5EE6AFA7E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14483" y="4702713"/>
              <a:ext cx="1080000" cy="1080000"/>
            </a:xfrm>
            <a:prstGeom prst="rect">
              <a:avLst/>
            </a:prstGeom>
            <a:noFill/>
            <a:ln w="127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3" name="グループ化 172">
            <a:extLst>
              <a:ext uri="{FF2B5EF4-FFF2-40B4-BE49-F238E27FC236}">
                <a16:creationId xmlns:a16="http://schemas.microsoft.com/office/drawing/2014/main" id="{D3EC12FC-6BF0-930F-E95D-ABFBA1A29FC3}"/>
              </a:ext>
            </a:extLst>
          </p:cNvPr>
          <p:cNvGrpSpPr/>
          <p:nvPr/>
        </p:nvGrpSpPr>
        <p:grpSpPr>
          <a:xfrm>
            <a:off x="765547" y="688996"/>
            <a:ext cx="1080000" cy="1080000"/>
            <a:chOff x="606517" y="5914401"/>
            <a:chExt cx="1080000" cy="1080000"/>
          </a:xfrm>
        </p:grpSpPr>
        <p:grpSp>
          <p:nvGrpSpPr>
            <p:cNvPr id="135" name="グループ化 134">
              <a:extLst>
                <a:ext uri="{FF2B5EF4-FFF2-40B4-BE49-F238E27FC236}">
                  <a16:creationId xmlns:a16="http://schemas.microsoft.com/office/drawing/2014/main" id="{2382A47A-9691-F785-92DB-4694BDAFCA6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06517" y="5914401"/>
              <a:ext cx="1080000" cy="1080000"/>
              <a:chOff x="661872" y="5546975"/>
              <a:chExt cx="4315968" cy="4315968"/>
            </a:xfrm>
          </p:grpSpPr>
          <p:pic>
            <p:nvPicPr>
              <p:cNvPr id="129" name="図 128">
                <a:extLst>
                  <a:ext uri="{FF2B5EF4-FFF2-40B4-BE49-F238E27FC236}">
                    <a16:creationId xmlns:a16="http://schemas.microsoft.com/office/drawing/2014/main" id="{E8A38F61-55DB-1158-D92F-95750390C9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1872" y="5546975"/>
                <a:ext cx="4315968" cy="4315968"/>
              </a:xfrm>
              <a:prstGeom prst="rect">
                <a:avLst/>
              </a:prstGeom>
              <a:ln w="12700">
                <a:solidFill>
                  <a:schemeClr val="bg1"/>
                </a:solidFill>
              </a:ln>
            </p:spPr>
          </p:pic>
          <p:sp>
            <p:nvSpPr>
              <p:cNvPr id="132" name="正方形/長方形 131">
                <a:extLst>
                  <a:ext uri="{FF2B5EF4-FFF2-40B4-BE49-F238E27FC236}">
                    <a16:creationId xmlns:a16="http://schemas.microsoft.com/office/drawing/2014/main" id="{1D44EB43-DCAA-D138-BB44-423580C166D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133336" y="5977183"/>
                <a:ext cx="1080000" cy="1080000"/>
              </a:xfrm>
              <a:prstGeom prst="rect">
                <a:avLst/>
              </a:prstGeom>
              <a:noFill/>
              <a:ln w="127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>
                  <a:ln>
                    <a:solidFill>
                      <a:schemeClr val="bg1">
                        <a:lumMod val="95000"/>
                      </a:schemeClr>
                    </a:solidFill>
                  </a:ln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0" name="フリーフォーム: 図形 139">
              <a:extLst>
                <a:ext uri="{FF2B5EF4-FFF2-40B4-BE49-F238E27FC236}">
                  <a16:creationId xmlns:a16="http://schemas.microsoft.com/office/drawing/2014/main" id="{6A1340BB-5030-E509-BF0F-B46168FCD866}"/>
                </a:ext>
              </a:extLst>
            </p:cNvPr>
            <p:cNvSpPr/>
            <p:nvPr/>
          </p:nvSpPr>
          <p:spPr>
            <a:xfrm>
              <a:off x="633401" y="5962961"/>
              <a:ext cx="929151" cy="1011039"/>
            </a:xfrm>
            <a:custGeom>
              <a:avLst/>
              <a:gdLst>
                <a:gd name="connsiteX0" fmla="*/ 538318 w 929151"/>
                <a:gd name="connsiteY0" fmla="*/ 104013 h 1011039"/>
                <a:gd name="connsiteX1" fmla="*/ 553067 w 929151"/>
                <a:gd name="connsiteY1" fmla="*/ 163007 h 1011039"/>
                <a:gd name="connsiteX2" fmla="*/ 589938 w 929151"/>
                <a:gd name="connsiteY2" fmla="*/ 207252 h 1011039"/>
                <a:gd name="connsiteX3" fmla="*/ 671054 w 929151"/>
                <a:gd name="connsiteY3" fmla="*/ 280994 h 1011039"/>
                <a:gd name="connsiteX4" fmla="*/ 693176 w 929151"/>
                <a:gd name="connsiteY4" fmla="*/ 317865 h 1011039"/>
                <a:gd name="connsiteX5" fmla="*/ 722673 w 929151"/>
                <a:gd name="connsiteY5" fmla="*/ 347362 h 1011039"/>
                <a:gd name="connsiteX6" fmla="*/ 737422 w 929151"/>
                <a:gd name="connsiteY6" fmla="*/ 362110 h 1011039"/>
                <a:gd name="connsiteX7" fmla="*/ 796415 w 929151"/>
                <a:gd name="connsiteY7" fmla="*/ 398981 h 1011039"/>
                <a:gd name="connsiteX8" fmla="*/ 825912 w 929151"/>
                <a:gd name="connsiteY8" fmla="*/ 435852 h 1011039"/>
                <a:gd name="connsiteX9" fmla="*/ 833286 w 929151"/>
                <a:gd name="connsiteY9" fmla="*/ 457975 h 1011039"/>
                <a:gd name="connsiteX10" fmla="*/ 862783 w 929151"/>
                <a:gd name="connsiteY10" fmla="*/ 480097 h 1011039"/>
                <a:gd name="connsiteX11" fmla="*/ 877531 w 929151"/>
                <a:gd name="connsiteY11" fmla="*/ 502220 h 1011039"/>
                <a:gd name="connsiteX12" fmla="*/ 892280 w 929151"/>
                <a:gd name="connsiteY12" fmla="*/ 561213 h 1011039"/>
                <a:gd name="connsiteX13" fmla="*/ 907028 w 929151"/>
                <a:gd name="connsiteY13" fmla="*/ 620207 h 1011039"/>
                <a:gd name="connsiteX14" fmla="*/ 914402 w 929151"/>
                <a:gd name="connsiteY14" fmla="*/ 649704 h 1011039"/>
                <a:gd name="connsiteX15" fmla="*/ 921776 w 929151"/>
                <a:gd name="connsiteY15" fmla="*/ 671826 h 1011039"/>
                <a:gd name="connsiteX16" fmla="*/ 929151 w 929151"/>
                <a:gd name="connsiteY16" fmla="*/ 716072 h 1011039"/>
                <a:gd name="connsiteX17" fmla="*/ 921776 w 929151"/>
                <a:gd name="connsiteY17" fmla="*/ 775065 h 1011039"/>
                <a:gd name="connsiteX18" fmla="*/ 907028 w 929151"/>
                <a:gd name="connsiteY18" fmla="*/ 797188 h 1011039"/>
                <a:gd name="connsiteX19" fmla="*/ 840660 w 929151"/>
                <a:gd name="connsiteY19" fmla="*/ 885678 h 1011039"/>
                <a:gd name="connsiteX20" fmla="*/ 818538 w 929151"/>
                <a:gd name="connsiteY20" fmla="*/ 1011039 h 1011039"/>
                <a:gd name="connsiteX21" fmla="*/ 744796 w 929151"/>
                <a:gd name="connsiteY21" fmla="*/ 988917 h 1011039"/>
                <a:gd name="connsiteX22" fmla="*/ 693176 w 929151"/>
                <a:gd name="connsiteY22" fmla="*/ 974168 h 1011039"/>
                <a:gd name="connsiteX23" fmla="*/ 648931 w 929151"/>
                <a:gd name="connsiteY23" fmla="*/ 966794 h 1011039"/>
                <a:gd name="connsiteX24" fmla="*/ 589938 w 929151"/>
                <a:gd name="connsiteY24" fmla="*/ 974168 h 1011039"/>
                <a:gd name="connsiteX25" fmla="*/ 545693 w 929151"/>
                <a:gd name="connsiteY25" fmla="*/ 988917 h 1011039"/>
                <a:gd name="connsiteX26" fmla="*/ 508822 w 929151"/>
                <a:gd name="connsiteY26" fmla="*/ 996291 h 1011039"/>
                <a:gd name="connsiteX27" fmla="*/ 442454 w 929151"/>
                <a:gd name="connsiteY27" fmla="*/ 1011039 h 1011039"/>
                <a:gd name="connsiteX28" fmla="*/ 412957 w 929151"/>
                <a:gd name="connsiteY28" fmla="*/ 981542 h 1011039"/>
                <a:gd name="connsiteX29" fmla="*/ 442454 w 929151"/>
                <a:gd name="connsiteY29" fmla="*/ 893052 h 1011039"/>
                <a:gd name="connsiteX30" fmla="*/ 449828 w 929151"/>
                <a:gd name="connsiteY30" fmla="*/ 870930 h 1011039"/>
                <a:gd name="connsiteX31" fmla="*/ 390834 w 929151"/>
                <a:gd name="connsiteY31" fmla="*/ 819310 h 1011039"/>
                <a:gd name="connsiteX32" fmla="*/ 376086 w 929151"/>
                <a:gd name="connsiteY32" fmla="*/ 797188 h 1011039"/>
                <a:gd name="connsiteX33" fmla="*/ 353964 w 929151"/>
                <a:gd name="connsiteY33" fmla="*/ 789813 h 1011039"/>
                <a:gd name="connsiteX34" fmla="*/ 324467 w 929151"/>
                <a:gd name="connsiteY34" fmla="*/ 775065 h 1011039"/>
                <a:gd name="connsiteX35" fmla="*/ 280222 w 929151"/>
                <a:gd name="connsiteY35" fmla="*/ 767691 h 1011039"/>
                <a:gd name="connsiteX36" fmla="*/ 250725 w 929151"/>
                <a:gd name="connsiteY36" fmla="*/ 760317 h 1011039"/>
                <a:gd name="connsiteX37" fmla="*/ 191731 w 929151"/>
                <a:gd name="connsiteY37" fmla="*/ 716072 h 1011039"/>
                <a:gd name="connsiteX38" fmla="*/ 169609 w 929151"/>
                <a:gd name="connsiteY38" fmla="*/ 620207 h 1011039"/>
                <a:gd name="connsiteX39" fmla="*/ 147486 w 929151"/>
                <a:gd name="connsiteY39" fmla="*/ 590710 h 1011039"/>
                <a:gd name="connsiteX40" fmla="*/ 103241 w 929151"/>
                <a:gd name="connsiteY40" fmla="*/ 561213 h 1011039"/>
                <a:gd name="connsiteX41" fmla="*/ 22125 w 929151"/>
                <a:gd name="connsiteY41" fmla="*/ 539091 h 1011039"/>
                <a:gd name="connsiteX42" fmla="*/ 7376 w 929151"/>
                <a:gd name="connsiteY42" fmla="*/ 502220 h 1011039"/>
                <a:gd name="connsiteX43" fmla="*/ 7376 w 929151"/>
                <a:gd name="connsiteY43" fmla="*/ 347362 h 1011039"/>
                <a:gd name="connsiteX44" fmla="*/ 36873 w 929151"/>
                <a:gd name="connsiteY44" fmla="*/ 266246 h 1011039"/>
                <a:gd name="connsiteX45" fmla="*/ 103241 w 929151"/>
                <a:gd name="connsiteY45" fmla="*/ 251497 h 1011039"/>
                <a:gd name="connsiteX46" fmla="*/ 125364 w 929151"/>
                <a:gd name="connsiteY46" fmla="*/ 222001 h 1011039"/>
                <a:gd name="connsiteX47" fmla="*/ 176983 w 929151"/>
                <a:gd name="connsiteY47" fmla="*/ 199878 h 1011039"/>
                <a:gd name="connsiteX48" fmla="*/ 228602 w 929151"/>
                <a:gd name="connsiteY48" fmla="*/ 170381 h 1011039"/>
                <a:gd name="connsiteX49" fmla="*/ 258099 w 929151"/>
                <a:gd name="connsiteY49" fmla="*/ 155633 h 1011039"/>
                <a:gd name="connsiteX50" fmla="*/ 302344 w 929151"/>
                <a:gd name="connsiteY50" fmla="*/ 96639 h 1011039"/>
                <a:gd name="connsiteX51" fmla="*/ 317093 w 929151"/>
                <a:gd name="connsiteY51" fmla="*/ 74517 h 1011039"/>
                <a:gd name="connsiteX52" fmla="*/ 331841 w 929151"/>
                <a:gd name="connsiteY52" fmla="*/ 45020 h 1011039"/>
                <a:gd name="connsiteX53" fmla="*/ 353964 w 929151"/>
                <a:gd name="connsiteY53" fmla="*/ 22897 h 1011039"/>
                <a:gd name="connsiteX54" fmla="*/ 361338 w 929151"/>
                <a:gd name="connsiteY54" fmla="*/ 775 h 1011039"/>
                <a:gd name="connsiteX55" fmla="*/ 479325 w 929151"/>
                <a:gd name="connsiteY55" fmla="*/ 37646 h 1011039"/>
                <a:gd name="connsiteX56" fmla="*/ 501447 w 929151"/>
                <a:gd name="connsiteY56" fmla="*/ 67142 h 1011039"/>
                <a:gd name="connsiteX57" fmla="*/ 538318 w 929151"/>
                <a:gd name="connsiteY57" fmla="*/ 104013 h 10110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</a:cxnLst>
              <a:rect l="l" t="t" r="r" b="b"/>
              <a:pathLst>
                <a:path w="929151" h="1011039">
                  <a:moveTo>
                    <a:pt x="538318" y="104013"/>
                  </a:moveTo>
                  <a:cubicBezTo>
                    <a:pt x="546921" y="119991"/>
                    <a:pt x="544002" y="144877"/>
                    <a:pt x="553067" y="163007"/>
                  </a:cubicBezTo>
                  <a:cubicBezTo>
                    <a:pt x="561653" y="180178"/>
                    <a:pt x="576916" y="193145"/>
                    <a:pt x="589938" y="207252"/>
                  </a:cubicBezTo>
                  <a:cubicBezTo>
                    <a:pt x="635173" y="256258"/>
                    <a:pt x="629703" y="249982"/>
                    <a:pt x="671054" y="280994"/>
                  </a:cubicBezTo>
                  <a:cubicBezTo>
                    <a:pt x="678428" y="293284"/>
                    <a:pt x="684377" y="306551"/>
                    <a:pt x="693176" y="317865"/>
                  </a:cubicBezTo>
                  <a:cubicBezTo>
                    <a:pt x="701713" y="328841"/>
                    <a:pt x="712841" y="337530"/>
                    <a:pt x="722673" y="347362"/>
                  </a:cubicBezTo>
                  <a:cubicBezTo>
                    <a:pt x="727589" y="352278"/>
                    <a:pt x="731637" y="358253"/>
                    <a:pt x="737422" y="362110"/>
                  </a:cubicBezTo>
                  <a:cubicBezTo>
                    <a:pt x="771469" y="384810"/>
                    <a:pt x="751944" y="372299"/>
                    <a:pt x="796415" y="398981"/>
                  </a:cubicBezTo>
                  <a:cubicBezTo>
                    <a:pt x="814950" y="454588"/>
                    <a:pt x="787791" y="388202"/>
                    <a:pt x="825912" y="435852"/>
                  </a:cubicBezTo>
                  <a:cubicBezTo>
                    <a:pt x="830768" y="441922"/>
                    <a:pt x="828310" y="452003"/>
                    <a:pt x="833286" y="457975"/>
                  </a:cubicBezTo>
                  <a:cubicBezTo>
                    <a:pt x="841154" y="467417"/>
                    <a:pt x="852951" y="472723"/>
                    <a:pt x="862783" y="480097"/>
                  </a:cubicBezTo>
                  <a:cubicBezTo>
                    <a:pt x="867699" y="487471"/>
                    <a:pt x="873568" y="494293"/>
                    <a:pt x="877531" y="502220"/>
                  </a:cubicBezTo>
                  <a:cubicBezTo>
                    <a:pt x="885585" y="518329"/>
                    <a:pt x="888675" y="545589"/>
                    <a:pt x="892280" y="561213"/>
                  </a:cubicBezTo>
                  <a:cubicBezTo>
                    <a:pt x="896838" y="580964"/>
                    <a:pt x="902112" y="600542"/>
                    <a:pt x="907028" y="620207"/>
                  </a:cubicBezTo>
                  <a:cubicBezTo>
                    <a:pt x="909486" y="630039"/>
                    <a:pt x="911197" y="640089"/>
                    <a:pt x="914402" y="649704"/>
                  </a:cubicBezTo>
                  <a:cubicBezTo>
                    <a:pt x="916860" y="657078"/>
                    <a:pt x="920090" y="664238"/>
                    <a:pt x="921776" y="671826"/>
                  </a:cubicBezTo>
                  <a:cubicBezTo>
                    <a:pt x="925020" y="686422"/>
                    <a:pt x="926693" y="701323"/>
                    <a:pt x="929151" y="716072"/>
                  </a:cubicBezTo>
                  <a:cubicBezTo>
                    <a:pt x="926693" y="735736"/>
                    <a:pt x="926990" y="755946"/>
                    <a:pt x="921776" y="775065"/>
                  </a:cubicBezTo>
                  <a:cubicBezTo>
                    <a:pt x="919444" y="783615"/>
                    <a:pt x="911673" y="789640"/>
                    <a:pt x="907028" y="797188"/>
                  </a:cubicBezTo>
                  <a:cubicBezTo>
                    <a:pt x="856102" y="879944"/>
                    <a:pt x="887290" y="854592"/>
                    <a:pt x="840660" y="885678"/>
                  </a:cubicBezTo>
                  <a:cubicBezTo>
                    <a:pt x="822503" y="976464"/>
                    <a:pt x="829457" y="934604"/>
                    <a:pt x="818538" y="1011039"/>
                  </a:cubicBezTo>
                  <a:cubicBezTo>
                    <a:pt x="779477" y="985000"/>
                    <a:pt x="810043" y="1000781"/>
                    <a:pt x="744796" y="988917"/>
                  </a:cubicBezTo>
                  <a:cubicBezTo>
                    <a:pt x="656468" y="972857"/>
                    <a:pt x="764252" y="989962"/>
                    <a:pt x="693176" y="974168"/>
                  </a:cubicBezTo>
                  <a:cubicBezTo>
                    <a:pt x="678580" y="970925"/>
                    <a:pt x="663679" y="969252"/>
                    <a:pt x="648931" y="966794"/>
                  </a:cubicBezTo>
                  <a:cubicBezTo>
                    <a:pt x="629267" y="969252"/>
                    <a:pt x="609315" y="970016"/>
                    <a:pt x="589938" y="974168"/>
                  </a:cubicBezTo>
                  <a:cubicBezTo>
                    <a:pt x="574737" y="977425"/>
                    <a:pt x="560937" y="985868"/>
                    <a:pt x="545693" y="988917"/>
                  </a:cubicBezTo>
                  <a:cubicBezTo>
                    <a:pt x="533403" y="991375"/>
                    <a:pt x="521057" y="993572"/>
                    <a:pt x="508822" y="996291"/>
                  </a:cubicBezTo>
                  <a:cubicBezTo>
                    <a:pt x="415095" y="1017119"/>
                    <a:pt x="553658" y="988799"/>
                    <a:pt x="442454" y="1011039"/>
                  </a:cubicBezTo>
                  <a:cubicBezTo>
                    <a:pt x="432622" y="1001207"/>
                    <a:pt x="415071" y="995285"/>
                    <a:pt x="412957" y="981542"/>
                  </a:cubicBezTo>
                  <a:cubicBezTo>
                    <a:pt x="406705" y="940906"/>
                    <a:pt x="424099" y="920584"/>
                    <a:pt x="442454" y="893052"/>
                  </a:cubicBezTo>
                  <a:cubicBezTo>
                    <a:pt x="444912" y="885678"/>
                    <a:pt x="451963" y="878404"/>
                    <a:pt x="449828" y="870930"/>
                  </a:cubicBezTo>
                  <a:cubicBezTo>
                    <a:pt x="442059" y="843739"/>
                    <a:pt x="411476" y="831695"/>
                    <a:pt x="390834" y="819310"/>
                  </a:cubicBezTo>
                  <a:cubicBezTo>
                    <a:pt x="385918" y="811936"/>
                    <a:pt x="383006" y="802724"/>
                    <a:pt x="376086" y="797188"/>
                  </a:cubicBezTo>
                  <a:cubicBezTo>
                    <a:pt x="370016" y="792332"/>
                    <a:pt x="361108" y="792875"/>
                    <a:pt x="353964" y="789813"/>
                  </a:cubicBezTo>
                  <a:cubicBezTo>
                    <a:pt x="343860" y="785483"/>
                    <a:pt x="334996" y="778224"/>
                    <a:pt x="324467" y="775065"/>
                  </a:cubicBezTo>
                  <a:cubicBezTo>
                    <a:pt x="310146" y="770769"/>
                    <a:pt x="294883" y="770623"/>
                    <a:pt x="280222" y="767691"/>
                  </a:cubicBezTo>
                  <a:cubicBezTo>
                    <a:pt x="270284" y="765703"/>
                    <a:pt x="260557" y="762775"/>
                    <a:pt x="250725" y="760317"/>
                  </a:cubicBezTo>
                  <a:cubicBezTo>
                    <a:pt x="226925" y="748416"/>
                    <a:pt x="206065" y="741872"/>
                    <a:pt x="191731" y="716072"/>
                  </a:cubicBezTo>
                  <a:cubicBezTo>
                    <a:pt x="165410" y="668695"/>
                    <a:pt x="211610" y="676207"/>
                    <a:pt x="169609" y="620207"/>
                  </a:cubicBezTo>
                  <a:cubicBezTo>
                    <a:pt x="162235" y="610375"/>
                    <a:pt x="156672" y="598875"/>
                    <a:pt x="147486" y="590710"/>
                  </a:cubicBezTo>
                  <a:cubicBezTo>
                    <a:pt x="134238" y="578934"/>
                    <a:pt x="120437" y="565512"/>
                    <a:pt x="103241" y="561213"/>
                  </a:cubicBezTo>
                  <a:cubicBezTo>
                    <a:pt x="56383" y="549499"/>
                    <a:pt x="83489" y="556623"/>
                    <a:pt x="22125" y="539091"/>
                  </a:cubicBezTo>
                  <a:cubicBezTo>
                    <a:pt x="17209" y="526801"/>
                    <a:pt x="10150" y="515163"/>
                    <a:pt x="7376" y="502220"/>
                  </a:cubicBezTo>
                  <a:cubicBezTo>
                    <a:pt x="-5465" y="442295"/>
                    <a:pt x="1077" y="410347"/>
                    <a:pt x="7376" y="347362"/>
                  </a:cubicBezTo>
                  <a:cubicBezTo>
                    <a:pt x="11084" y="310286"/>
                    <a:pt x="3348" y="285403"/>
                    <a:pt x="36873" y="266246"/>
                  </a:cubicBezTo>
                  <a:cubicBezTo>
                    <a:pt x="42478" y="263043"/>
                    <a:pt x="101017" y="251942"/>
                    <a:pt x="103241" y="251497"/>
                  </a:cubicBezTo>
                  <a:cubicBezTo>
                    <a:pt x="110615" y="241665"/>
                    <a:pt x="116033" y="229999"/>
                    <a:pt x="125364" y="222001"/>
                  </a:cubicBezTo>
                  <a:cubicBezTo>
                    <a:pt x="146852" y="203583"/>
                    <a:pt x="155011" y="210864"/>
                    <a:pt x="176983" y="199878"/>
                  </a:cubicBezTo>
                  <a:cubicBezTo>
                    <a:pt x="194708" y="191015"/>
                    <a:pt x="211204" y="179871"/>
                    <a:pt x="228602" y="170381"/>
                  </a:cubicBezTo>
                  <a:cubicBezTo>
                    <a:pt x="238253" y="165117"/>
                    <a:pt x="248267" y="160549"/>
                    <a:pt x="258099" y="155633"/>
                  </a:cubicBezTo>
                  <a:cubicBezTo>
                    <a:pt x="285381" y="128349"/>
                    <a:pt x="268989" y="146671"/>
                    <a:pt x="302344" y="96639"/>
                  </a:cubicBezTo>
                  <a:cubicBezTo>
                    <a:pt x="307260" y="89265"/>
                    <a:pt x="313130" y="82444"/>
                    <a:pt x="317093" y="74517"/>
                  </a:cubicBezTo>
                  <a:cubicBezTo>
                    <a:pt x="322009" y="64685"/>
                    <a:pt x="325452" y="53965"/>
                    <a:pt x="331841" y="45020"/>
                  </a:cubicBezTo>
                  <a:cubicBezTo>
                    <a:pt x="337903" y="36534"/>
                    <a:pt x="346590" y="30271"/>
                    <a:pt x="353964" y="22897"/>
                  </a:cubicBezTo>
                  <a:cubicBezTo>
                    <a:pt x="356422" y="15523"/>
                    <a:pt x="353588" y="1371"/>
                    <a:pt x="361338" y="775"/>
                  </a:cubicBezTo>
                  <a:cubicBezTo>
                    <a:pt x="409022" y="-2893"/>
                    <a:pt x="447659" y="5980"/>
                    <a:pt x="479325" y="37646"/>
                  </a:cubicBezTo>
                  <a:cubicBezTo>
                    <a:pt x="488015" y="46336"/>
                    <a:pt x="491446" y="59999"/>
                    <a:pt x="501447" y="67142"/>
                  </a:cubicBezTo>
                  <a:cubicBezTo>
                    <a:pt x="509694" y="73033"/>
                    <a:pt x="529715" y="88035"/>
                    <a:pt x="538318" y="104013"/>
                  </a:cubicBezTo>
                  <a:close/>
                </a:path>
              </a:pathLst>
            </a:custGeom>
            <a:noFill/>
            <a:ln w="19050">
              <a:solidFill>
                <a:schemeClr val="bg1">
                  <a:lumMod val="85000"/>
                </a:schemeClr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0494416B-9562-DE39-B281-45B35A7719E9}"/>
              </a:ext>
            </a:extLst>
          </p:cNvPr>
          <p:cNvCxnSpPr>
            <a:cxnSpLocks/>
          </p:cNvCxnSpPr>
          <p:nvPr/>
        </p:nvCxnSpPr>
        <p:spPr>
          <a:xfrm>
            <a:off x="3606486" y="233983"/>
            <a:ext cx="327600" cy="0"/>
          </a:xfrm>
          <a:prstGeom prst="line">
            <a:avLst/>
          </a:prstGeom>
          <a:ln w="349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23FBBA9-F553-05A7-BC54-3A1ED2C8B6CD}"/>
              </a:ext>
            </a:extLst>
          </p:cNvPr>
          <p:cNvSpPr txBox="1"/>
          <p:nvPr/>
        </p:nvSpPr>
        <p:spPr>
          <a:xfrm rot="16200000">
            <a:off x="3353272" y="2252098"/>
            <a:ext cx="1220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agnified ima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図 56">
            <a:extLst>
              <a:ext uri="{FF2B5EF4-FFF2-40B4-BE49-F238E27FC236}">
                <a16:creationId xmlns:a16="http://schemas.microsoft.com/office/drawing/2014/main" id="{7564BD06-4FB3-B9F6-24C1-517FE866DC6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0199" y="688996"/>
            <a:ext cx="1078992" cy="1078992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C43229EE-6DE5-60E5-3E27-099B82D636C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405" y="688996"/>
            <a:ext cx="1078993" cy="1078993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CDE71BE7-A721-E986-272D-B65ECB7BD09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8607" y="688996"/>
            <a:ext cx="1078995" cy="1078995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D197AA1A-B2CA-A99F-D8D5-ECC12E92739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7139" y="3038225"/>
            <a:ext cx="1080000" cy="1080000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E7EF4D35-FF31-61DE-4A4F-3C98B94B5D8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458" y="3039282"/>
            <a:ext cx="1078994" cy="1078994"/>
          </a:xfrm>
          <a:prstGeom prst="rect">
            <a:avLst/>
          </a:prstGeom>
          <a:ln w="12700">
            <a:solidFill>
              <a:schemeClr val="bg1"/>
            </a:solidFill>
          </a:ln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id="{F95A9786-2346-7BA3-E77C-888B8F2DB71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2105" y="3039229"/>
            <a:ext cx="1078996" cy="1078996"/>
          </a:xfrm>
          <a:prstGeom prst="rect">
            <a:avLst/>
          </a:prstGeom>
        </p:spPr>
      </p:pic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81780E28-4C27-3C96-BF28-46F28266DD81}"/>
              </a:ext>
            </a:extLst>
          </p:cNvPr>
          <p:cNvSpPr txBox="1"/>
          <p:nvPr/>
        </p:nvSpPr>
        <p:spPr>
          <a:xfrm>
            <a:off x="706059" y="658671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4E057B66-FD31-EDDD-30F2-9386312E1B55}"/>
              </a:ext>
            </a:extLst>
          </p:cNvPr>
          <p:cNvSpPr txBox="1"/>
          <p:nvPr/>
        </p:nvSpPr>
        <p:spPr>
          <a:xfrm>
            <a:off x="1844090" y="658671"/>
            <a:ext cx="554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X1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80D3B54-E2B8-40AA-9A41-5AD66B427144}"/>
              </a:ext>
            </a:extLst>
          </p:cNvPr>
          <p:cNvSpPr txBox="1"/>
          <p:nvPr/>
        </p:nvSpPr>
        <p:spPr>
          <a:xfrm>
            <a:off x="2976046" y="658671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TC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D3792A58-D549-7947-4C9D-1361F196D5B8}"/>
              </a:ext>
            </a:extLst>
          </p:cNvPr>
          <p:cNvSpPr txBox="1"/>
          <p:nvPr/>
        </p:nvSpPr>
        <p:spPr>
          <a:xfrm>
            <a:off x="4111187" y="652538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/SNX1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8670E710-45BE-6976-9534-ED92C046DA98}"/>
              </a:ext>
            </a:extLst>
          </p:cNvPr>
          <p:cNvSpPr txBox="1"/>
          <p:nvPr/>
        </p:nvSpPr>
        <p:spPr>
          <a:xfrm>
            <a:off x="5249394" y="652538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B66D69C5-9E59-0D81-D6F1-BD34E3D9B7D6}"/>
              </a:ext>
            </a:extLst>
          </p:cNvPr>
          <p:cNvSpPr txBox="1"/>
          <p:nvPr/>
        </p:nvSpPr>
        <p:spPr>
          <a:xfrm>
            <a:off x="716775" y="3011073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AFA989F0-835B-8AEE-FF53-9871BC58AEC0}"/>
              </a:ext>
            </a:extLst>
          </p:cNvPr>
          <p:cNvSpPr txBox="1"/>
          <p:nvPr/>
        </p:nvSpPr>
        <p:spPr>
          <a:xfrm>
            <a:off x="1854806" y="3011073"/>
            <a:ext cx="5549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X1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059D07D0-AC48-7163-2E78-7CEA8BFBBD46}"/>
              </a:ext>
            </a:extLst>
          </p:cNvPr>
          <p:cNvSpPr txBox="1"/>
          <p:nvPr/>
        </p:nvSpPr>
        <p:spPr>
          <a:xfrm>
            <a:off x="2986762" y="3011073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TC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94300ED7-9B7A-7F06-1EA8-3890AAC37507}"/>
              </a:ext>
            </a:extLst>
          </p:cNvPr>
          <p:cNvSpPr txBox="1"/>
          <p:nvPr/>
        </p:nvSpPr>
        <p:spPr>
          <a:xfrm>
            <a:off x="4121903" y="3004940"/>
            <a:ext cx="8835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/SNX1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9712ED0-C405-4814-F994-8020C03DC3D4}"/>
              </a:ext>
            </a:extLst>
          </p:cNvPr>
          <p:cNvSpPr txBox="1"/>
          <p:nvPr/>
        </p:nvSpPr>
        <p:spPr>
          <a:xfrm>
            <a:off x="5260110" y="3004940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kumimoji="1" lang="ja-JP" altLang="en-US" sz="11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4E61BD66-A9D0-04EB-DBC7-AF3BF23B1258}"/>
              </a:ext>
            </a:extLst>
          </p:cNvPr>
          <p:cNvSpPr txBox="1"/>
          <p:nvPr/>
        </p:nvSpPr>
        <p:spPr>
          <a:xfrm rot="16200000">
            <a:off x="-444657" y="2882984"/>
            <a:ext cx="1550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FP-DNAJC13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ΔC425</a:t>
            </a: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83965171-F845-747F-2D36-12AA7976AB42}"/>
              </a:ext>
            </a:extLst>
          </p:cNvPr>
          <p:cNvSpPr txBox="1"/>
          <p:nvPr/>
        </p:nvSpPr>
        <p:spPr>
          <a:xfrm rot="16200000">
            <a:off x="55708" y="1104862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072E2DBF-38A6-732D-276B-562EAACA49A3}"/>
              </a:ext>
            </a:extLst>
          </p:cNvPr>
          <p:cNvSpPr txBox="1"/>
          <p:nvPr/>
        </p:nvSpPr>
        <p:spPr>
          <a:xfrm rot="16200000">
            <a:off x="97596" y="3451925"/>
            <a:ext cx="1051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LTC siRN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0F05C67E-D2FD-2F2A-28CE-27C162EFB713}"/>
              </a:ext>
            </a:extLst>
          </p:cNvPr>
          <p:cNvCxnSpPr>
            <a:cxnSpLocks/>
          </p:cNvCxnSpPr>
          <p:nvPr/>
        </p:nvCxnSpPr>
        <p:spPr>
          <a:xfrm flipV="1">
            <a:off x="499003" y="688996"/>
            <a:ext cx="0" cy="454991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直線コネクタ 140">
            <a:extLst>
              <a:ext uri="{FF2B5EF4-FFF2-40B4-BE49-F238E27FC236}">
                <a16:creationId xmlns:a16="http://schemas.microsoft.com/office/drawing/2014/main" id="{E5FE6E3E-871E-F233-5B32-E26368713720}"/>
              </a:ext>
            </a:extLst>
          </p:cNvPr>
          <p:cNvCxnSpPr>
            <a:cxnSpLocks/>
          </p:cNvCxnSpPr>
          <p:nvPr/>
        </p:nvCxnSpPr>
        <p:spPr>
          <a:xfrm>
            <a:off x="5969613" y="1696723"/>
            <a:ext cx="327600" cy="0"/>
          </a:xfrm>
          <a:prstGeom prst="line">
            <a:avLst/>
          </a:prstGeom>
          <a:ln w="349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379ADA0B-E456-1F3A-4283-7806B5C32E7E}"/>
              </a:ext>
            </a:extLst>
          </p:cNvPr>
          <p:cNvCxnSpPr>
            <a:cxnSpLocks/>
          </p:cNvCxnSpPr>
          <p:nvPr/>
        </p:nvCxnSpPr>
        <p:spPr>
          <a:xfrm>
            <a:off x="5973111" y="4036677"/>
            <a:ext cx="327600" cy="0"/>
          </a:xfrm>
          <a:prstGeom prst="line">
            <a:avLst/>
          </a:prstGeom>
          <a:ln w="349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E8D5BB44-4050-32C8-4D55-1EAACC344CF4}"/>
              </a:ext>
            </a:extLst>
          </p:cNvPr>
          <p:cNvGrpSpPr>
            <a:grpSpLocks noChangeAspect="1"/>
          </p:cNvGrpSpPr>
          <p:nvPr/>
        </p:nvGrpSpPr>
        <p:grpSpPr>
          <a:xfrm>
            <a:off x="4157173" y="1825923"/>
            <a:ext cx="1080000" cy="1077571"/>
            <a:chOff x="2133336" y="5977183"/>
            <a:chExt cx="1082435" cy="1080000"/>
          </a:xfrm>
        </p:grpSpPr>
        <p:pic>
          <p:nvPicPr>
            <p:cNvPr id="144" name="図 143">
              <a:extLst>
                <a:ext uri="{FF2B5EF4-FFF2-40B4-BE49-F238E27FC236}">
                  <a16:creationId xmlns:a16="http://schemas.microsoft.com/office/drawing/2014/main" id="{66163FF3-6367-9642-0B3E-B085F129BC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97" t="9969" r="40827" b="65055"/>
            <a:stretch/>
          </p:blipFill>
          <p:spPr>
            <a:xfrm>
              <a:off x="2137781" y="5977183"/>
              <a:ext cx="1077990" cy="1077988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45" name="正方形/長方形 144">
              <a:extLst>
                <a:ext uri="{FF2B5EF4-FFF2-40B4-BE49-F238E27FC236}">
                  <a16:creationId xmlns:a16="http://schemas.microsoft.com/office/drawing/2014/main" id="{3955F4B6-042B-8A85-1388-781C8A88B29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133336" y="5977183"/>
              <a:ext cx="1080000" cy="1080000"/>
            </a:xfrm>
            <a:prstGeom prst="rect">
              <a:avLst/>
            </a:prstGeom>
            <a:noFill/>
            <a:ln w="38100">
              <a:solidFill>
                <a:srgbClr val="5AF0D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id="{B9A0C4C8-1066-C0E8-FA99-964F8B6BB344}"/>
              </a:ext>
            </a:extLst>
          </p:cNvPr>
          <p:cNvGrpSpPr>
            <a:grpSpLocks noChangeAspect="1"/>
          </p:cNvGrpSpPr>
          <p:nvPr/>
        </p:nvGrpSpPr>
        <p:grpSpPr>
          <a:xfrm>
            <a:off x="5317253" y="1816188"/>
            <a:ext cx="1080000" cy="1075480"/>
            <a:chOff x="3914483" y="4702713"/>
            <a:chExt cx="1084539" cy="1080000"/>
          </a:xfrm>
        </p:grpSpPr>
        <p:pic>
          <p:nvPicPr>
            <p:cNvPr id="147" name="図 146">
              <a:extLst>
                <a:ext uri="{FF2B5EF4-FFF2-40B4-BE49-F238E27FC236}">
                  <a16:creationId xmlns:a16="http://schemas.microsoft.com/office/drawing/2014/main" id="{8E029DB9-62FF-BC4C-41A7-6DA2338706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56" t="9967" r="40766" b="65056"/>
            <a:stretch/>
          </p:blipFill>
          <p:spPr>
            <a:xfrm>
              <a:off x="3921033" y="4702713"/>
              <a:ext cx="1077989" cy="1077989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48" name="正方形/長方形 147">
              <a:extLst>
                <a:ext uri="{FF2B5EF4-FFF2-40B4-BE49-F238E27FC236}">
                  <a16:creationId xmlns:a16="http://schemas.microsoft.com/office/drawing/2014/main" id="{6A22ECE7-FB36-C8FF-9178-6D3C68B8949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14483" y="4702713"/>
              <a:ext cx="1080000" cy="1080000"/>
            </a:xfrm>
            <a:prstGeom prst="rect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F553FEDD-9EAB-C670-6EB3-DBE614502E8E}"/>
              </a:ext>
            </a:extLst>
          </p:cNvPr>
          <p:cNvGrpSpPr>
            <a:grpSpLocks noChangeAspect="1"/>
          </p:cNvGrpSpPr>
          <p:nvPr/>
        </p:nvGrpSpPr>
        <p:grpSpPr>
          <a:xfrm>
            <a:off x="4168493" y="4167004"/>
            <a:ext cx="1080420" cy="1080000"/>
            <a:chOff x="-1031342" y="6292235"/>
            <a:chExt cx="1086550" cy="1086127"/>
          </a:xfrm>
        </p:grpSpPr>
        <p:pic>
          <p:nvPicPr>
            <p:cNvPr id="167" name="図 166">
              <a:extLst>
                <a:ext uri="{FF2B5EF4-FFF2-40B4-BE49-F238E27FC236}">
                  <a16:creationId xmlns:a16="http://schemas.microsoft.com/office/drawing/2014/main" id="{2539A317-416F-B317-8124-76D3303CBB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13" t="54649" r="57189" b="20375"/>
            <a:stretch/>
          </p:blipFill>
          <p:spPr>
            <a:xfrm>
              <a:off x="-1028020" y="6292235"/>
              <a:ext cx="1083228" cy="1077987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68" name="正方形/長方形 167">
              <a:extLst>
                <a:ext uri="{FF2B5EF4-FFF2-40B4-BE49-F238E27FC236}">
                  <a16:creationId xmlns:a16="http://schemas.microsoft.com/office/drawing/2014/main" id="{3A19A81C-9149-3206-C96E-C1D7DB55CC6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-1031342" y="6298362"/>
              <a:ext cx="1080000" cy="1080000"/>
            </a:xfrm>
            <a:prstGeom prst="rect">
              <a:avLst/>
            </a:prstGeom>
            <a:noFill/>
            <a:ln w="38100">
              <a:solidFill>
                <a:srgbClr val="5AF0DE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F4B4B5B2-6F27-86DA-0476-9D6765C71F43}"/>
              </a:ext>
            </a:extLst>
          </p:cNvPr>
          <p:cNvGrpSpPr/>
          <p:nvPr/>
        </p:nvGrpSpPr>
        <p:grpSpPr>
          <a:xfrm>
            <a:off x="5306593" y="4163935"/>
            <a:ext cx="1081009" cy="1081009"/>
            <a:chOff x="-1031342" y="6291843"/>
            <a:chExt cx="1080000" cy="1080000"/>
          </a:xfrm>
        </p:grpSpPr>
        <p:pic>
          <p:nvPicPr>
            <p:cNvPr id="171" name="図 170">
              <a:extLst>
                <a:ext uri="{FF2B5EF4-FFF2-40B4-BE49-F238E27FC236}">
                  <a16:creationId xmlns:a16="http://schemas.microsoft.com/office/drawing/2014/main" id="{7B85961A-5BEC-6C53-B348-0CEC5AF20C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42" t="54405" r="57335" b="20663"/>
            <a:stretch/>
          </p:blipFill>
          <p:spPr>
            <a:xfrm>
              <a:off x="-1031342" y="6294739"/>
              <a:ext cx="1075670" cy="1076096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72" name="正方形/長方形 171">
              <a:extLst>
                <a:ext uri="{FF2B5EF4-FFF2-40B4-BE49-F238E27FC236}">
                  <a16:creationId xmlns:a16="http://schemas.microsoft.com/office/drawing/2014/main" id="{45C8AD10-FC43-9B71-A5F6-CE4A23A727F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-1031342" y="6291843"/>
              <a:ext cx="1080000" cy="1080000"/>
            </a:xfrm>
            <a:prstGeom prst="rect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>
                <a:ln>
                  <a:solidFill>
                    <a:schemeClr val="bg1">
                      <a:lumMod val="95000"/>
                    </a:schemeClr>
                  </a:solidFill>
                </a:ln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98CF7188-36D4-24A8-4907-8851C40FB4B1}"/>
              </a:ext>
            </a:extLst>
          </p:cNvPr>
          <p:cNvSpPr txBox="1"/>
          <p:nvPr/>
        </p:nvSpPr>
        <p:spPr>
          <a:xfrm rot="16200000">
            <a:off x="3358310" y="4603450"/>
            <a:ext cx="1220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Magnified image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52F60BBD-9C91-1193-A4CB-4688892502B5}"/>
              </a:ext>
            </a:extLst>
          </p:cNvPr>
          <p:cNvSpPr txBox="1"/>
          <p:nvPr/>
        </p:nvSpPr>
        <p:spPr>
          <a:xfrm>
            <a:off x="0" y="58917"/>
            <a:ext cx="3490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76A13B7F-5376-A589-7D40-A289D4DA4598}"/>
              </a:ext>
            </a:extLst>
          </p:cNvPr>
          <p:cNvSpPr txBox="1"/>
          <p:nvPr/>
        </p:nvSpPr>
        <p:spPr>
          <a:xfrm>
            <a:off x="349701" y="6033153"/>
            <a:ext cx="603356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NAi-mediated silencing of endogenous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lathri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eavy chain (CLTC) in COS7 cells expressing  GFP-DNAJC1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ΔC42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ree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. siRNA used were as follows: CLTC (s475;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rmo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isher Scientific) and control (sc-37007; Santa Cruz).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fluorescenc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of GFP-DNAJC1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ΔC42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exists with SNX1 (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agent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and the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NX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negative tubular structures </a:t>
            </a:r>
            <a:r>
              <a:rPr lang="en-US" altLang="ja-JP" sz="12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re markedly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hortened in CLTC (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lu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knockdown cells compared to control cells. Th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hite dotted lines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dicate outline of the cells.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cale ba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2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9770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11</TotalTime>
  <Words>112</Words>
  <Application>Microsoft Office PowerPoint</Application>
  <PresentationFormat>A4 210 x 297 mm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da Shun</dc:creator>
  <cp:lastModifiedBy>Shun Yoshida</cp:lastModifiedBy>
  <cp:revision>29</cp:revision>
  <cp:lastPrinted>2023-07-08T05:31:09Z</cp:lastPrinted>
  <dcterms:created xsi:type="dcterms:W3CDTF">2023-03-01T14:27:50Z</dcterms:created>
  <dcterms:modified xsi:type="dcterms:W3CDTF">2023-12-15T11:17:53Z</dcterms:modified>
</cp:coreProperties>
</file>